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9" autoAdjust="0"/>
    <p:restoredTop sz="94660"/>
  </p:normalViewPr>
  <p:slideViewPr>
    <p:cSldViewPr snapToGrid="0">
      <p:cViewPr>
        <p:scale>
          <a:sx n="110" d="100"/>
          <a:sy n="110" d="100"/>
        </p:scale>
        <p:origin x="162" y="13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5F8F47-A9D5-4CDB-9A4C-A1CA9CA5A76A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7E013D-873D-4537-9A4F-092013F4F7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585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.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7E013D-873D-4537-9A4F-092013F4F7A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9123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16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236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20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163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627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862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85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669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214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594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664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BD7F7-736F-4636-B77D-1E05ADA6E256}" type="datetimeFigureOut">
              <a:rPr lang="en-GB" smtClean="0"/>
              <a:t>1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99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21DA6EA-175B-4D91-86CC-E549076184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66" y="890953"/>
            <a:ext cx="6353567" cy="7507634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B92C227F-37B2-4E82-9B45-A889F6D972D8}"/>
              </a:ext>
            </a:extLst>
          </p:cNvPr>
          <p:cNvGrpSpPr/>
          <p:nvPr/>
        </p:nvGrpSpPr>
        <p:grpSpPr>
          <a:xfrm>
            <a:off x="855785" y="762489"/>
            <a:ext cx="5578548" cy="5287108"/>
            <a:chOff x="855785" y="890954"/>
            <a:chExt cx="5578548" cy="5287108"/>
          </a:xfrm>
        </p:grpSpPr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4CE37DD0-C1FE-4DA1-83DA-B3E39D4ABBB8}"/>
                </a:ext>
              </a:extLst>
            </p:cNvPr>
            <p:cNvCxnSpPr/>
            <p:nvPr/>
          </p:nvCxnSpPr>
          <p:spPr>
            <a:xfrm>
              <a:off x="855785" y="890954"/>
              <a:ext cx="557854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32EE884B-2444-4E37-B71D-6D78FBCDA247}"/>
                </a:ext>
              </a:extLst>
            </p:cNvPr>
            <p:cNvCxnSpPr/>
            <p:nvPr/>
          </p:nvCxnSpPr>
          <p:spPr>
            <a:xfrm>
              <a:off x="855785" y="890954"/>
              <a:ext cx="0" cy="528710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A11AE1C2-81A6-42CF-9E56-B378801A6A69}"/>
                </a:ext>
              </a:extLst>
            </p:cNvPr>
            <p:cNvCxnSpPr>
              <a:cxnSpLocks/>
            </p:cNvCxnSpPr>
            <p:nvPr/>
          </p:nvCxnSpPr>
          <p:spPr>
            <a:xfrm>
              <a:off x="855785" y="6178062"/>
              <a:ext cx="44279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42C8D5D-554A-489F-95C7-D40FC1629D1E}"/>
              </a:ext>
            </a:extLst>
          </p:cNvPr>
          <p:cNvCxnSpPr/>
          <p:nvPr/>
        </p:nvCxnSpPr>
        <p:spPr>
          <a:xfrm flipV="1">
            <a:off x="1298575" y="5318125"/>
            <a:ext cx="0" cy="73147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D003212-93B5-485C-9E34-A4189912A6A3}"/>
              </a:ext>
            </a:extLst>
          </p:cNvPr>
          <p:cNvCxnSpPr>
            <a:cxnSpLocks/>
          </p:cNvCxnSpPr>
          <p:nvPr/>
        </p:nvCxnSpPr>
        <p:spPr>
          <a:xfrm flipV="1">
            <a:off x="1298575" y="5318125"/>
            <a:ext cx="5135758" cy="1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FA66259-E5A1-4337-A523-30B1E282CE8E}"/>
              </a:ext>
            </a:extLst>
          </p:cNvPr>
          <p:cNvCxnSpPr>
            <a:cxnSpLocks/>
          </p:cNvCxnSpPr>
          <p:nvPr/>
        </p:nvCxnSpPr>
        <p:spPr>
          <a:xfrm flipV="1">
            <a:off x="6434333" y="762489"/>
            <a:ext cx="0" cy="45556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30355A4-DECB-4A39-B5CD-30ACECCFEA71}"/>
              </a:ext>
            </a:extLst>
          </p:cNvPr>
          <p:cNvCxnSpPr/>
          <p:nvPr/>
        </p:nvCxnSpPr>
        <p:spPr>
          <a:xfrm>
            <a:off x="1298575" y="5353499"/>
            <a:ext cx="0" cy="71995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78C16EC-58D3-4937-B3D1-BD1FB9CF3333}"/>
              </a:ext>
            </a:extLst>
          </p:cNvPr>
          <p:cNvCxnSpPr/>
          <p:nvPr/>
        </p:nvCxnSpPr>
        <p:spPr>
          <a:xfrm>
            <a:off x="1298575" y="5353499"/>
            <a:ext cx="51357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B5B35A03-274B-46C8-BC8E-C072A19ECD87}"/>
              </a:ext>
            </a:extLst>
          </p:cNvPr>
          <p:cNvCxnSpPr/>
          <p:nvPr/>
        </p:nvCxnSpPr>
        <p:spPr>
          <a:xfrm>
            <a:off x="6434333" y="5353499"/>
            <a:ext cx="0" cy="1436915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A93D238-E939-464B-BF54-6989FFDFA961}"/>
              </a:ext>
            </a:extLst>
          </p:cNvPr>
          <p:cNvCxnSpPr/>
          <p:nvPr/>
        </p:nvCxnSpPr>
        <p:spPr>
          <a:xfrm flipH="1">
            <a:off x="855785" y="6073450"/>
            <a:ext cx="44279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F23D870-F473-4CB3-9F50-DE576869E117}"/>
              </a:ext>
            </a:extLst>
          </p:cNvPr>
          <p:cNvCxnSpPr>
            <a:cxnSpLocks/>
          </p:cNvCxnSpPr>
          <p:nvPr/>
        </p:nvCxnSpPr>
        <p:spPr>
          <a:xfrm>
            <a:off x="855785" y="6071956"/>
            <a:ext cx="0" cy="155158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0E4F60B-B335-420A-B97D-F3A771E02AB8}"/>
              </a:ext>
            </a:extLst>
          </p:cNvPr>
          <p:cNvCxnSpPr>
            <a:cxnSpLocks/>
          </p:cNvCxnSpPr>
          <p:nvPr/>
        </p:nvCxnSpPr>
        <p:spPr>
          <a:xfrm>
            <a:off x="855785" y="7623542"/>
            <a:ext cx="264695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B8E27FB7-F6C8-4A3A-B17A-ACC569F8AEFB}"/>
              </a:ext>
            </a:extLst>
          </p:cNvPr>
          <p:cNvCxnSpPr/>
          <p:nvPr/>
        </p:nvCxnSpPr>
        <p:spPr>
          <a:xfrm flipH="1">
            <a:off x="3502742" y="6790414"/>
            <a:ext cx="293159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975A0B4-8C7F-4ED2-BD79-E9629E44531D}"/>
              </a:ext>
            </a:extLst>
          </p:cNvPr>
          <p:cNvCxnSpPr/>
          <p:nvPr/>
        </p:nvCxnSpPr>
        <p:spPr>
          <a:xfrm>
            <a:off x="3502742" y="6790414"/>
            <a:ext cx="0" cy="83312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909DCF52-022E-432E-940B-EEBAB7D6D2DB}"/>
              </a:ext>
            </a:extLst>
          </p:cNvPr>
          <p:cNvCxnSpPr/>
          <p:nvPr/>
        </p:nvCxnSpPr>
        <p:spPr>
          <a:xfrm>
            <a:off x="3526188" y="6847749"/>
            <a:ext cx="0" cy="775793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8D9DDADC-E33E-4689-A75F-5F3B5497E550}"/>
              </a:ext>
            </a:extLst>
          </p:cNvPr>
          <p:cNvCxnSpPr/>
          <p:nvPr/>
        </p:nvCxnSpPr>
        <p:spPr>
          <a:xfrm>
            <a:off x="3526188" y="6847749"/>
            <a:ext cx="2908145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1E476C3-4141-4864-99BE-5EA53F099877}"/>
              </a:ext>
            </a:extLst>
          </p:cNvPr>
          <p:cNvCxnSpPr/>
          <p:nvPr/>
        </p:nvCxnSpPr>
        <p:spPr>
          <a:xfrm>
            <a:off x="6434333" y="6847749"/>
            <a:ext cx="0" cy="1463913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3A5F3516-CD20-41FA-BE98-CA3C42FC52B4}"/>
              </a:ext>
            </a:extLst>
          </p:cNvPr>
          <p:cNvCxnSpPr>
            <a:cxnSpLocks/>
          </p:cNvCxnSpPr>
          <p:nvPr/>
        </p:nvCxnSpPr>
        <p:spPr>
          <a:xfrm flipH="1">
            <a:off x="855785" y="8311662"/>
            <a:ext cx="5578548" cy="797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95D5B9F-C4F0-42CD-9E34-D0BC22D839F5}"/>
              </a:ext>
            </a:extLst>
          </p:cNvPr>
          <p:cNvCxnSpPr/>
          <p:nvPr/>
        </p:nvCxnSpPr>
        <p:spPr>
          <a:xfrm flipV="1">
            <a:off x="855785" y="7623542"/>
            <a:ext cx="0" cy="69609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F1D8E11-3074-4695-8CC9-46B4FC1FFD77}"/>
              </a:ext>
            </a:extLst>
          </p:cNvPr>
          <p:cNvCxnSpPr/>
          <p:nvPr/>
        </p:nvCxnSpPr>
        <p:spPr>
          <a:xfrm>
            <a:off x="855785" y="7623542"/>
            <a:ext cx="2670403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84A9AFC-EB76-4156-8B12-572D506336ED}"/>
              </a:ext>
            </a:extLst>
          </p:cNvPr>
          <p:cNvGrpSpPr/>
          <p:nvPr/>
        </p:nvGrpSpPr>
        <p:grpSpPr>
          <a:xfrm>
            <a:off x="3138330" y="1463611"/>
            <a:ext cx="598675" cy="258934"/>
            <a:chOff x="2927513" y="313557"/>
            <a:chExt cx="598675" cy="258934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EFA1F82-47D4-4A7E-9740-C759146A76E8}"/>
                </a:ext>
              </a:extLst>
            </p:cNvPr>
            <p:cNvSpPr txBox="1"/>
            <p:nvPr/>
          </p:nvSpPr>
          <p:spPr>
            <a:xfrm>
              <a:off x="2927513" y="313557"/>
              <a:ext cx="598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G/A</a:t>
              </a: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B02CC032-3491-47F4-AF23-DF73BD3C3C09}"/>
                </a:ext>
              </a:extLst>
            </p:cNvPr>
            <p:cNvCxnSpPr>
              <a:cxnSpLocks/>
            </p:cNvCxnSpPr>
            <p:nvPr/>
          </p:nvCxnSpPr>
          <p:spPr>
            <a:xfrm>
              <a:off x="3104007" y="479897"/>
              <a:ext cx="1" cy="9259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61E6D138-1FB0-4BDD-81F2-351BE8EE5C8A}"/>
              </a:ext>
            </a:extLst>
          </p:cNvPr>
          <p:cNvGrpSpPr/>
          <p:nvPr/>
        </p:nvGrpSpPr>
        <p:grpSpPr>
          <a:xfrm>
            <a:off x="6188795" y="6212557"/>
            <a:ext cx="598675" cy="258934"/>
            <a:chOff x="2927513" y="313557"/>
            <a:chExt cx="598675" cy="258934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5640A3A-744F-4BEA-91DB-675A9399E6B5}"/>
                </a:ext>
              </a:extLst>
            </p:cNvPr>
            <p:cNvSpPr txBox="1"/>
            <p:nvPr/>
          </p:nvSpPr>
          <p:spPr>
            <a:xfrm>
              <a:off x="2927513" y="313557"/>
              <a:ext cx="598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G/A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FB1E93FB-0DB3-4A21-B07A-DC265E248E40}"/>
                </a:ext>
              </a:extLst>
            </p:cNvPr>
            <p:cNvCxnSpPr>
              <a:cxnSpLocks/>
            </p:cNvCxnSpPr>
            <p:nvPr/>
          </p:nvCxnSpPr>
          <p:spPr>
            <a:xfrm>
              <a:off x="3104007" y="479897"/>
              <a:ext cx="1" cy="9259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7AC76283-C26E-4F6F-B225-DE411475716B}"/>
              </a:ext>
            </a:extLst>
          </p:cNvPr>
          <p:cNvGrpSpPr/>
          <p:nvPr/>
        </p:nvGrpSpPr>
        <p:grpSpPr>
          <a:xfrm>
            <a:off x="1459792" y="7184059"/>
            <a:ext cx="598675" cy="258934"/>
            <a:chOff x="2927513" y="313557"/>
            <a:chExt cx="598675" cy="258934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6A71757-47D0-4391-8A93-A8A690CC2E73}"/>
                </a:ext>
              </a:extLst>
            </p:cNvPr>
            <p:cNvSpPr txBox="1"/>
            <p:nvPr/>
          </p:nvSpPr>
          <p:spPr>
            <a:xfrm>
              <a:off x="2927513" y="313557"/>
              <a:ext cx="598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G/A</a:t>
              </a:r>
            </a:p>
          </p:txBody>
        </p: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F706808F-5DEF-439E-A1CD-AC0078F5CBCB}"/>
                </a:ext>
              </a:extLst>
            </p:cNvPr>
            <p:cNvCxnSpPr>
              <a:cxnSpLocks/>
            </p:cNvCxnSpPr>
            <p:nvPr/>
          </p:nvCxnSpPr>
          <p:spPr>
            <a:xfrm>
              <a:off x="3104007" y="479897"/>
              <a:ext cx="1" cy="9259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BC8A38A8-2681-4C13-A6E9-F76E6D63EE37}"/>
              </a:ext>
            </a:extLst>
          </p:cNvPr>
          <p:cNvSpPr txBox="1"/>
          <p:nvPr/>
        </p:nvSpPr>
        <p:spPr>
          <a:xfrm>
            <a:off x="435429" y="8621486"/>
            <a:ext cx="59989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igure S1. Alignment of coding regions of TaIRX9b homeologues. The three exons are indicated by boxes; stop-gained mutations are shown.</a:t>
            </a:r>
          </a:p>
        </p:txBody>
      </p:sp>
    </p:spTree>
    <p:extLst>
      <p:ext uri="{BB962C8B-B14F-4D97-AF65-F5344CB8AC3E}">
        <p14:creationId xmlns:p14="http://schemas.microsoft.com/office/powerpoint/2010/main" val="1208106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77</TotalTime>
  <Words>37</Words>
  <Application>Microsoft Office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wan Mitchell</dc:creator>
  <cp:lastModifiedBy>Rowan Mitchell</cp:lastModifiedBy>
  <cp:revision>70</cp:revision>
  <dcterms:created xsi:type="dcterms:W3CDTF">2018-11-08T10:54:33Z</dcterms:created>
  <dcterms:modified xsi:type="dcterms:W3CDTF">2019-08-15T14:01:35Z</dcterms:modified>
</cp:coreProperties>
</file>